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36" userDrawn="1">
          <p15:clr>
            <a:srgbClr val="A4A3A4"/>
          </p15:clr>
        </p15:guide>
        <p15:guide id="2" pos="28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1929" y="60"/>
      </p:cViewPr>
      <p:guideLst>
        <p:guide orient="horz" pos="2336"/>
        <p:guide pos="28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4665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575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6115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77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3171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1214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650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891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0087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319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397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240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E:\hip1 8HRS RF (8)\hip1 8HRS RF (8)_(c1+c2)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13" t="36807"/>
          <a:stretch/>
        </p:blipFill>
        <p:spPr bwMode="auto">
          <a:xfrm>
            <a:off x="3254316" y="2000608"/>
            <a:ext cx="1195775" cy="8719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7" descr="E:\hip1_NS1_12\hip1_NS1_12\hip1_NS1_12_(c1+c3)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73" t="30244" b="7497"/>
          <a:stretch/>
        </p:blipFill>
        <p:spPr bwMode="auto">
          <a:xfrm>
            <a:off x="3265949" y="1081333"/>
            <a:ext cx="1195775" cy="8608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2" descr="E:\WT_NS1_15\WT_NS1_15_(c1+c4)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10" t="1" b="38608"/>
          <a:stretch/>
        </p:blipFill>
        <p:spPr bwMode="auto">
          <a:xfrm>
            <a:off x="1995977" y="1081333"/>
            <a:ext cx="1195775" cy="850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5" descr="E:\WT 8HRS RF (1)\WT 8HRS RF (1)_(c1+c2)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0" t="11354" r="20958" b="25073"/>
          <a:stretch/>
        </p:blipFill>
        <p:spPr bwMode="auto">
          <a:xfrm>
            <a:off x="1995977" y="2000608"/>
            <a:ext cx="1195775" cy="8691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TextBox 56"/>
          <p:cNvSpPr txBox="1">
            <a:spLocks noChangeAspect="1"/>
          </p:cNvSpPr>
          <p:nvPr/>
        </p:nvSpPr>
        <p:spPr>
          <a:xfrm>
            <a:off x="4415913" y="1384670"/>
            <a:ext cx="3640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lang="en-GB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415913" y="2296680"/>
            <a:ext cx="5982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N 8h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419092" y="82712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585913" y="827123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ip1∆</a:t>
            </a:r>
            <a:endParaRPr lang="en-GB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43467" y="3273931"/>
            <a:ext cx="571217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Early G0 </a:t>
            </a:r>
            <a:r>
              <a:rPr lang="en-GB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∆ cells initiate growth in response to restoration of a nitrogen source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ld type and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strains were starved for nitroge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or 1 day (-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) at 30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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A nitrogen source was restored by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uspending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n rich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YES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edium for 8 hours (+N 8h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t 30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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Cells were stained with DAPI </a:t>
            </a:r>
            <a:r>
              <a:rPr lang="en-GB" sz="11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nd </a:t>
            </a:r>
            <a:r>
              <a:rPr lang="en-GB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visualised by d</a:t>
            </a:r>
            <a:r>
              <a:rPr lang="en-GB" sz="1100" dirty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ifferential interference contrast (DIC) and fluorescence </a:t>
            </a:r>
            <a:r>
              <a:rPr lang="en-GB" sz="1100" dirty="0" smtClean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microscopy</a:t>
            </a:r>
            <a:r>
              <a:rPr lang="en-GB" sz="1200" dirty="0" smtClean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.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7860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9D959B2D8FA5C4980890EF71530081A" ma:contentTypeVersion="14" ma:contentTypeDescription="Create a new document." ma:contentTypeScope="" ma:versionID="32fa3c235032fb6ef437c97435266abb">
  <xsd:schema xmlns:xsd="http://www.w3.org/2001/XMLSchema" xmlns:xs="http://www.w3.org/2001/XMLSchema" xmlns:p="http://schemas.microsoft.com/office/2006/metadata/properties" xmlns:ns3="1ff86b73-d2ed-45d1-9e31-5b4a0d263f49" xmlns:ns4="917767b3-d7cc-4621-8ad9-27e46fe3c43e" targetNamespace="http://schemas.microsoft.com/office/2006/metadata/properties" ma:root="true" ma:fieldsID="b46a7b92e6b6a21088fcbb1ddad5d57c" ns3:_="" ns4:_="">
    <xsd:import namespace="1ff86b73-d2ed-45d1-9e31-5b4a0d263f49"/>
    <xsd:import namespace="917767b3-d7cc-4621-8ad9-27e46fe3c43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f86b73-d2ed-45d1-9e31-5b4a0d263f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17767b3-d7cc-4621-8ad9-27e46fe3c43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ff86b73-d2ed-45d1-9e31-5b4a0d263f49" xsi:nil="true"/>
  </documentManagement>
</p:properties>
</file>

<file path=customXml/itemProps1.xml><?xml version="1.0" encoding="utf-8"?>
<ds:datastoreItem xmlns:ds="http://schemas.openxmlformats.org/officeDocument/2006/customXml" ds:itemID="{3295711E-8CCD-4178-B937-97EE8CEE62C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f86b73-d2ed-45d1-9e31-5b4a0d263f49"/>
    <ds:schemaRef ds:uri="917767b3-d7cc-4621-8ad9-27e46fe3c43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188CCFF-7F7C-482C-8934-4CAD0556FD9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0E2F7B3-9C6C-466A-8942-79BD95D03D77}">
  <ds:schemaRefs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1ff86b73-d2ed-45d1-9e31-5b4a0d263f49"/>
    <ds:schemaRef ds:uri="http://purl.org/dc/terms/"/>
    <ds:schemaRef ds:uri="http://schemas.openxmlformats.org/package/2006/metadata/core-properties"/>
    <ds:schemaRef ds:uri="917767b3-d7cc-4621-8ad9-27e46fe3c43e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1</TotalTime>
  <Words>8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Whitehall</dc:creator>
  <cp:lastModifiedBy>Simon_Admin</cp:lastModifiedBy>
  <cp:revision>37</cp:revision>
  <cp:lastPrinted>2018-05-04T14:46:18Z</cp:lastPrinted>
  <dcterms:created xsi:type="dcterms:W3CDTF">2017-02-01T13:08:09Z</dcterms:created>
  <dcterms:modified xsi:type="dcterms:W3CDTF">2023-06-28T14:25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9D959B2D8FA5C4980890EF71530081A</vt:lpwstr>
  </property>
</Properties>
</file>